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20" autoAdjust="0"/>
    <p:restoredTop sz="94660"/>
  </p:normalViewPr>
  <p:slideViewPr>
    <p:cSldViewPr snapToGrid="0">
      <p:cViewPr varScale="1">
        <p:scale>
          <a:sx n="59" d="100"/>
          <a:sy n="59" d="100"/>
        </p:scale>
        <p:origin x="84" y="7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FAEB14-A0DA-413C-BD32-B9A1E1CB7ED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72CCC96-8401-4069-8042-B2E78C532B7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01E0E8-1514-4EE2-BCA8-838D4DA453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D2470-4BED-4E76-B66E-5B79F6CD308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229414-5F59-4239-BD45-6D0594B107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A380BD-C3EC-4DEF-B9E2-BC4DEAA0E7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45A15-3651-4DEA-8EC5-FF35344B0D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0458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DF395F-1BB3-454B-A518-0F8F178E76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1C5102D-2272-47AD-BA73-D93A0CD031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B544D5-EFF4-4F7E-9319-2AC3ACB57E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D2470-4BED-4E76-B66E-5B79F6CD308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AC522B-6F38-4837-9777-3126D4398D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2E25A47-E766-4651-AAAC-2FA5D797B2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45A15-3651-4DEA-8EC5-FF35344B0D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89885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F5A0FC7-B943-4666-85CE-1FE5D925558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98EBD3F-6810-4137-985D-3FDC57B1A6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48989B-7726-431D-82E1-23F5704119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D2470-4BED-4E76-B66E-5B79F6CD308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E6C540-003E-4498-BE58-D455765BCF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8BDD52-5E18-4363-A930-4D77328E6E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45A15-3651-4DEA-8EC5-FF35344B0D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12175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AAA6D2-7570-4076-B479-A6B9BEAD9A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5C61CD1-7ECB-4216-9D11-CF8D7728AC4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B1CAB2-5D88-4C00-9B1B-E3F5364DAE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D2470-4BED-4E76-B66E-5B79F6CD308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A50248-645A-4032-A470-A0819B91F4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A465F6-B1B9-4D11-B36B-78A67B8AA0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45A15-3651-4DEA-8EC5-FF35344B0D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67078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FD5746-FAF3-483E-8BB4-78567C1CD5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8E50D08-8948-4AC6-8556-7435ED4D8CD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1659B8-8040-490A-B1BB-D0FE4C18EE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D2470-4BED-4E76-B66E-5B79F6CD308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5566E5-280D-4E67-BCB1-1D018FB299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D09A0A-09B7-42A7-A1C2-7DB1DAA3B7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45A15-3651-4DEA-8EC5-FF35344B0D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41701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A4CEF9-1257-47D5-A187-EA505A0C89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53D7EF2-577A-4A4A-862B-03FA1A63D52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1F01A57-A7D1-48EC-A2EC-6406C4FCD72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7A4CE64-EBE6-495E-A77C-5D7CBF1485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D2470-4BED-4E76-B66E-5B79F6CD308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FBB6676-166D-475A-9B2E-2E8245262D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059B28C-F500-4F3A-9BAB-C4F1115935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45A15-3651-4DEA-8EC5-FF35344B0D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90014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6A2923-741A-46E1-80BD-6F43A74118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4812135-4947-49B4-A511-19ED2E602F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427C3A8-D54C-4CC8-9031-E19F5194EE1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229DFBC-40B5-4CE3-8AB3-34111107C0F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1424113-FED6-4F38-B272-115E7A1FDD7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760AFAB-5A3B-4809-9767-327AA79C9B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D2470-4BED-4E76-B66E-5B79F6CD308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D621F0E-D8F3-4CA4-AAAA-B7D1C6DE92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DA3F71E-D8EE-496E-8BB4-7251EC1D06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45A15-3651-4DEA-8EC5-FF35344B0D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75132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3A1C7D-DD09-4648-BC83-3DA39B7F74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BF36893-7D2D-4EF9-8EB4-A34649997F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D2470-4BED-4E76-B66E-5B79F6CD308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FAE66F7-FF3A-4C56-B145-BBE3CDF0A0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703D9AB-787F-45EE-958F-338D844028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45A15-3651-4DEA-8EC5-FF35344B0D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84573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55EE8ED-27C7-4D6C-A022-CE76D80357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D2470-4BED-4E76-B66E-5B79F6CD308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9592EA3-D8F1-460E-812B-F480798766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9566240-9AF3-499B-B263-417B89D24F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45A15-3651-4DEA-8EC5-FF35344B0D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75429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E92915-37EB-4C88-8BB1-1AB1420FE9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EE5F16-8BED-4C7B-B071-4CD5D847E1B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AC8CD66-CE7D-4F13-9A17-A17DCCC9C4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9B81079-4924-49D5-8346-4652872116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D2470-4BED-4E76-B66E-5B79F6CD308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1EFEFA4-7A71-480E-92F0-8C14442D76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30BD7BA-0F90-40D2-A98E-C08E1DC5DF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45A15-3651-4DEA-8EC5-FF35344B0D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51971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F0B292-F8BD-4395-95F6-9A400B4CAE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9EFA1A3-21B2-48A0-8980-62FF3A5AF44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A8E64A9-EE47-4397-B748-E0EF85A2AD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62B340C-6BB6-4C9D-AAEB-8A83A8D4F4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CD2470-4BED-4E76-B66E-5B79F6CD308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DB32CB6-E7DC-4516-B7E5-3FBD0E36DD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0367DEE-120E-47AD-A372-3AB0144990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A45A15-3651-4DEA-8EC5-FF35344B0D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40879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37AF786-A348-4E78-86E4-8D5D45D2A1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26CF09E-FD97-4DF4-84A4-54582CE023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2C8C0F-43BD-47D8-A6C2-FE7163C7527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CD2470-4BED-4E76-B66E-5B79F6CD308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658B26-E781-4484-950D-EB55FD3B013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66DE0F-8290-477F-9C5F-84EF8CDD5A1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A45A15-3651-4DEA-8EC5-FF35344B0D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06240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>
            <a:extLst>
              <a:ext uri="{FF2B5EF4-FFF2-40B4-BE49-F238E27FC236}">
                <a16:creationId xmlns:a16="http://schemas.microsoft.com/office/drawing/2014/main" id="{793ECF66-219A-4F44-BFB4-B4D83ABD8EC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08172" y="3229375"/>
            <a:ext cx="5838000" cy="29190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4D1F6651-0FCF-4314-B8EE-DDBC4789258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629" t="384" b="-1"/>
          <a:stretch/>
        </p:blipFill>
        <p:spPr>
          <a:xfrm>
            <a:off x="8241174" y="378440"/>
            <a:ext cx="3838869" cy="2364759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BF85C451-2519-4012-AED9-ACA0A099A6B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2532" y="369332"/>
            <a:ext cx="7408333" cy="3704167"/>
          </a:xfrm>
          <a:prstGeom prst="rect">
            <a:avLst/>
          </a:prstGeom>
        </p:spPr>
      </p:pic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7D8E53AC-6F6C-424F-9874-74A702A46CEB}"/>
              </a:ext>
            </a:extLst>
          </p:cNvPr>
          <p:cNvCxnSpPr/>
          <p:nvPr/>
        </p:nvCxnSpPr>
        <p:spPr>
          <a:xfrm flipH="1">
            <a:off x="7444433" y="1117600"/>
            <a:ext cx="1482739" cy="3302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88F1B68C-0AFA-4D7D-ACB6-13EEB929A931}"/>
              </a:ext>
            </a:extLst>
          </p:cNvPr>
          <p:cNvCxnSpPr/>
          <p:nvPr/>
        </p:nvCxnSpPr>
        <p:spPr>
          <a:xfrm flipH="1">
            <a:off x="4419600" y="660400"/>
            <a:ext cx="6426200" cy="38363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CFBEC677-5E12-8646-973A-8E87F5ADF149}"/>
              </a:ext>
            </a:extLst>
          </p:cNvPr>
          <p:cNvSpPr txBox="1"/>
          <p:nvPr/>
        </p:nvSpPr>
        <p:spPr>
          <a:xfrm>
            <a:off x="7349222" y="3271535"/>
            <a:ext cx="3598022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iological pathways common to both time groups of females</a:t>
            </a:r>
          </a:p>
        </p:txBody>
      </p:sp>
      <p:sp>
        <p:nvSpPr>
          <p:cNvPr id="10" name="Title 1">
            <a:extLst>
              <a:ext uri="{FF2B5EF4-FFF2-40B4-BE49-F238E27FC236}">
                <a16:creationId xmlns:a16="http://schemas.microsoft.com/office/drawing/2014/main" id="{CC6F1AAE-2588-2D44-97D2-21F230C0147A}"/>
              </a:ext>
            </a:extLst>
          </p:cNvPr>
          <p:cNvSpPr txBox="1">
            <a:spLocks/>
          </p:cNvSpPr>
          <p:nvPr/>
        </p:nvSpPr>
        <p:spPr>
          <a:xfrm>
            <a:off x="0" y="-88145"/>
            <a:ext cx="10515600" cy="1325563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800" dirty="0"/>
              <a:t>Supplemental Figure 3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651ADCD-C9D0-494A-BD79-17227D92AF5A}"/>
              </a:ext>
            </a:extLst>
          </p:cNvPr>
          <p:cNvSpPr txBox="1"/>
          <p:nvPr/>
        </p:nvSpPr>
        <p:spPr>
          <a:xfrm>
            <a:off x="2453833" y="423287"/>
            <a:ext cx="355433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elected biological pathways in females for each time group</a:t>
            </a:r>
          </a:p>
        </p:txBody>
      </p: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F5D39A53-DCAD-494B-B857-CB3D0F8AD78E}"/>
              </a:ext>
            </a:extLst>
          </p:cNvPr>
          <p:cNvCxnSpPr>
            <a:cxnSpLocks/>
          </p:cNvCxnSpPr>
          <p:nvPr/>
        </p:nvCxnSpPr>
        <p:spPr>
          <a:xfrm flipH="1">
            <a:off x="9861452" y="2142067"/>
            <a:ext cx="239283" cy="112946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06F43D09-C946-1440-B209-0B24195E0255}"/>
              </a:ext>
            </a:extLst>
          </p:cNvPr>
          <p:cNvSpPr txBox="1"/>
          <p:nvPr/>
        </p:nvSpPr>
        <p:spPr>
          <a:xfrm>
            <a:off x="7607034" y="314811"/>
            <a:ext cx="1268280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emale samples ≥ 60 days 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C867982-183B-2643-A5F4-0AC5CE36390C}"/>
              </a:ext>
            </a:extLst>
          </p:cNvPr>
          <p:cNvSpPr txBox="1"/>
          <p:nvPr/>
        </p:nvSpPr>
        <p:spPr>
          <a:xfrm>
            <a:off x="11451278" y="237867"/>
            <a:ext cx="863379" cy="55399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emale samples &lt; 60 days </a:t>
            </a:r>
          </a:p>
        </p:txBody>
      </p:sp>
    </p:spTree>
    <p:extLst>
      <p:ext uri="{BB962C8B-B14F-4D97-AF65-F5344CB8AC3E}">
        <p14:creationId xmlns:p14="http://schemas.microsoft.com/office/powerpoint/2010/main" val="25734711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1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opra, Sunita (NIH/NCI) [F]</dc:creator>
  <cp:lastModifiedBy>Chopra, Sunita (NIH/NCI) [F]</cp:lastModifiedBy>
  <cp:revision>1</cp:revision>
  <dcterms:created xsi:type="dcterms:W3CDTF">2022-05-12T17:09:25Z</dcterms:created>
  <dcterms:modified xsi:type="dcterms:W3CDTF">2022-05-12T17:09:56Z</dcterms:modified>
</cp:coreProperties>
</file>